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9" r:id="rId3"/>
    <p:sldId id="258" r:id="rId4"/>
  </p:sldIdLst>
  <p:sldSz cx="13992225" cy="7578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7" userDrawn="1">
          <p15:clr>
            <a:srgbClr val="A4A3A4"/>
          </p15:clr>
        </p15:guide>
        <p15:guide id="2" pos="44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2"/>
  </p:normalViewPr>
  <p:slideViewPr>
    <p:cSldViewPr snapToGrid="0" snapToObjects="1" showGuides="1">
      <p:cViewPr varScale="1">
        <p:scale>
          <a:sx n="72" d="100"/>
          <a:sy n="72" d="100"/>
        </p:scale>
        <p:origin x="667" y="53"/>
      </p:cViewPr>
      <p:guideLst>
        <p:guide orient="horz" pos="2387"/>
        <p:guide pos="440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49028" y="1240315"/>
            <a:ext cx="10494169" cy="2638519"/>
          </a:xfrm>
        </p:spPr>
        <p:txBody>
          <a:bodyPr anchor="b"/>
          <a:lstStyle>
            <a:lvl1pPr algn="ctr">
              <a:defRPr sz="663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49028" y="3980586"/>
            <a:ext cx="10494169" cy="1829770"/>
          </a:xfrm>
        </p:spPr>
        <p:txBody>
          <a:bodyPr/>
          <a:lstStyle>
            <a:lvl1pPr marL="0" indent="0" algn="ctr">
              <a:buNone/>
              <a:defRPr sz="2652"/>
            </a:lvl1pPr>
            <a:lvl2pPr marL="505252" indent="0" algn="ctr">
              <a:buNone/>
              <a:defRPr sz="2210"/>
            </a:lvl2pPr>
            <a:lvl3pPr marL="1010503" indent="0" algn="ctr">
              <a:buNone/>
              <a:defRPr sz="1989"/>
            </a:lvl3pPr>
            <a:lvl4pPr marL="1515755" indent="0" algn="ctr">
              <a:buNone/>
              <a:defRPr sz="1768"/>
            </a:lvl4pPr>
            <a:lvl5pPr marL="2021007" indent="0" algn="ctr">
              <a:buNone/>
              <a:defRPr sz="1768"/>
            </a:lvl5pPr>
            <a:lvl6pPr marL="2526259" indent="0" algn="ctr">
              <a:buNone/>
              <a:defRPr sz="1768"/>
            </a:lvl6pPr>
            <a:lvl7pPr marL="3031510" indent="0" algn="ctr">
              <a:buNone/>
              <a:defRPr sz="1768"/>
            </a:lvl7pPr>
            <a:lvl8pPr marL="3536762" indent="0" algn="ctr">
              <a:buNone/>
              <a:defRPr sz="1768"/>
            </a:lvl8pPr>
            <a:lvl9pPr marL="4042014" indent="0" algn="ctr">
              <a:buNone/>
              <a:defRPr sz="1768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0290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38775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013186" y="403497"/>
            <a:ext cx="3017074" cy="642261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61965" y="403497"/>
            <a:ext cx="8876318" cy="642261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9359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61436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4678" y="1889419"/>
            <a:ext cx="12068294" cy="3152539"/>
          </a:xfrm>
        </p:spPr>
        <p:txBody>
          <a:bodyPr anchor="b"/>
          <a:lstStyle>
            <a:lvl1pPr>
              <a:defRPr sz="663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4678" y="5071782"/>
            <a:ext cx="12068294" cy="1657846"/>
          </a:xfrm>
        </p:spPr>
        <p:txBody>
          <a:bodyPr/>
          <a:lstStyle>
            <a:lvl1pPr marL="0" indent="0">
              <a:buNone/>
              <a:defRPr sz="2652">
                <a:solidFill>
                  <a:schemeClr val="tx1">
                    <a:tint val="75000"/>
                  </a:schemeClr>
                </a:solidFill>
              </a:defRPr>
            </a:lvl1pPr>
            <a:lvl2pPr marL="505252" indent="0">
              <a:buNone/>
              <a:defRPr sz="2210">
                <a:solidFill>
                  <a:schemeClr val="tx1">
                    <a:tint val="75000"/>
                  </a:schemeClr>
                </a:solidFill>
              </a:defRPr>
            </a:lvl2pPr>
            <a:lvl3pPr marL="1010503" indent="0">
              <a:buNone/>
              <a:defRPr sz="1989">
                <a:solidFill>
                  <a:schemeClr val="tx1">
                    <a:tint val="75000"/>
                  </a:schemeClr>
                </a:solidFill>
              </a:defRPr>
            </a:lvl3pPr>
            <a:lvl4pPr marL="1515755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4pPr>
            <a:lvl5pPr marL="2021007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5pPr>
            <a:lvl6pPr marL="2526259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6pPr>
            <a:lvl7pPr marL="3031510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7pPr>
            <a:lvl8pPr marL="3536762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8pPr>
            <a:lvl9pPr marL="4042014" indent="0">
              <a:buNone/>
              <a:defRPr sz="17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95146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61965" y="2017485"/>
            <a:ext cx="5946696" cy="4808631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3564" y="2017485"/>
            <a:ext cx="5946696" cy="4808631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52574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788" y="403497"/>
            <a:ext cx="12068294" cy="146487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789" y="1857841"/>
            <a:ext cx="5919366" cy="910499"/>
          </a:xfrm>
        </p:spPr>
        <p:txBody>
          <a:bodyPr anchor="b"/>
          <a:lstStyle>
            <a:lvl1pPr marL="0" indent="0">
              <a:buNone/>
              <a:defRPr sz="2652" b="1"/>
            </a:lvl1pPr>
            <a:lvl2pPr marL="505252" indent="0">
              <a:buNone/>
              <a:defRPr sz="2210" b="1"/>
            </a:lvl2pPr>
            <a:lvl3pPr marL="1010503" indent="0">
              <a:buNone/>
              <a:defRPr sz="1989" b="1"/>
            </a:lvl3pPr>
            <a:lvl4pPr marL="1515755" indent="0">
              <a:buNone/>
              <a:defRPr sz="1768" b="1"/>
            </a:lvl4pPr>
            <a:lvl5pPr marL="2021007" indent="0">
              <a:buNone/>
              <a:defRPr sz="1768" b="1"/>
            </a:lvl5pPr>
            <a:lvl6pPr marL="2526259" indent="0">
              <a:buNone/>
              <a:defRPr sz="1768" b="1"/>
            </a:lvl6pPr>
            <a:lvl7pPr marL="3031510" indent="0">
              <a:buNone/>
              <a:defRPr sz="1768" b="1"/>
            </a:lvl7pPr>
            <a:lvl8pPr marL="3536762" indent="0">
              <a:buNone/>
              <a:defRPr sz="1768" b="1"/>
            </a:lvl8pPr>
            <a:lvl9pPr marL="4042014" indent="0">
              <a:buNone/>
              <a:defRPr sz="1768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63789" y="2768340"/>
            <a:ext cx="5919366" cy="4071811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83564" y="1857841"/>
            <a:ext cx="5948518" cy="910499"/>
          </a:xfrm>
        </p:spPr>
        <p:txBody>
          <a:bodyPr anchor="b"/>
          <a:lstStyle>
            <a:lvl1pPr marL="0" indent="0">
              <a:buNone/>
              <a:defRPr sz="2652" b="1"/>
            </a:lvl1pPr>
            <a:lvl2pPr marL="505252" indent="0">
              <a:buNone/>
              <a:defRPr sz="2210" b="1"/>
            </a:lvl2pPr>
            <a:lvl3pPr marL="1010503" indent="0">
              <a:buNone/>
              <a:defRPr sz="1989" b="1"/>
            </a:lvl3pPr>
            <a:lvl4pPr marL="1515755" indent="0">
              <a:buNone/>
              <a:defRPr sz="1768" b="1"/>
            </a:lvl4pPr>
            <a:lvl5pPr marL="2021007" indent="0">
              <a:buNone/>
              <a:defRPr sz="1768" b="1"/>
            </a:lvl5pPr>
            <a:lvl6pPr marL="2526259" indent="0">
              <a:buNone/>
              <a:defRPr sz="1768" b="1"/>
            </a:lvl6pPr>
            <a:lvl7pPr marL="3031510" indent="0">
              <a:buNone/>
              <a:defRPr sz="1768" b="1"/>
            </a:lvl7pPr>
            <a:lvl8pPr marL="3536762" indent="0">
              <a:buNone/>
              <a:defRPr sz="1768" b="1"/>
            </a:lvl8pPr>
            <a:lvl9pPr marL="4042014" indent="0">
              <a:buNone/>
              <a:defRPr sz="1768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83564" y="2768340"/>
            <a:ext cx="5948518" cy="4071811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42801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67411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49899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789" y="505248"/>
            <a:ext cx="4512856" cy="1768369"/>
          </a:xfrm>
        </p:spPr>
        <p:txBody>
          <a:bodyPr anchor="b"/>
          <a:lstStyle>
            <a:lvl1pPr>
              <a:defRPr sz="353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48518" y="1091197"/>
            <a:ext cx="7083564" cy="5385807"/>
          </a:xfrm>
        </p:spPr>
        <p:txBody>
          <a:bodyPr/>
          <a:lstStyle>
            <a:lvl1pPr>
              <a:defRPr sz="3536"/>
            </a:lvl1pPr>
            <a:lvl2pPr>
              <a:defRPr sz="3094"/>
            </a:lvl2pPr>
            <a:lvl3pPr>
              <a:defRPr sz="2652"/>
            </a:lvl3pPr>
            <a:lvl4pPr>
              <a:defRPr sz="2210"/>
            </a:lvl4pPr>
            <a:lvl5pPr>
              <a:defRPr sz="2210"/>
            </a:lvl5pPr>
            <a:lvl6pPr>
              <a:defRPr sz="2210"/>
            </a:lvl6pPr>
            <a:lvl7pPr>
              <a:defRPr sz="2210"/>
            </a:lvl7pPr>
            <a:lvl8pPr>
              <a:defRPr sz="2210"/>
            </a:lvl8pPr>
            <a:lvl9pPr>
              <a:defRPr sz="221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3789" y="2273617"/>
            <a:ext cx="4512856" cy="4212158"/>
          </a:xfrm>
        </p:spPr>
        <p:txBody>
          <a:bodyPr/>
          <a:lstStyle>
            <a:lvl1pPr marL="0" indent="0">
              <a:buNone/>
              <a:defRPr sz="1768"/>
            </a:lvl1pPr>
            <a:lvl2pPr marL="505252" indent="0">
              <a:buNone/>
              <a:defRPr sz="1547"/>
            </a:lvl2pPr>
            <a:lvl3pPr marL="1010503" indent="0">
              <a:buNone/>
              <a:defRPr sz="1326"/>
            </a:lvl3pPr>
            <a:lvl4pPr marL="1515755" indent="0">
              <a:buNone/>
              <a:defRPr sz="1105"/>
            </a:lvl4pPr>
            <a:lvl5pPr marL="2021007" indent="0">
              <a:buNone/>
              <a:defRPr sz="1105"/>
            </a:lvl5pPr>
            <a:lvl6pPr marL="2526259" indent="0">
              <a:buNone/>
              <a:defRPr sz="1105"/>
            </a:lvl6pPr>
            <a:lvl7pPr marL="3031510" indent="0">
              <a:buNone/>
              <a:defRPr sz="1105"/>
            </a:lvl7pPr>
            <a:lvl8pPr marL="3536762" indent="0">
              <a:buNone/>
              <a:defRPr sz="1105"/>
            </a:lvl8pPr>
            <a:lvl9pPr marL="4042014" indent="0">
              <a:buNone/>
              <a:defRPr sz="110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44910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789" y="505248"/>
            <a:ext cx="4512856" cy="1768369"/>
          </a:xfrm>
        </p:spPr>
        <p:txBody>
          <a:bodyPr anchor="b"/>
          <a:lstStyle>
            <a:lvl1pPr>
              <a:defRPr sz="353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948518" y="1091197"/>
            <a:ext cx="7083564" cy="5385807"/>
          </a:xfrm>
        </p:spPr>
        <p:txBody>
          <a:bodyPr anchor="t"/>
          <a:lstStyle>
            <a:lvl1pPr marL="0" indent="0">
              <a:buNone/>
              <a:defRPr sz="3536"/>
            </a:lvl1pPr>
            <a:lvl2pPr marL="505252" indent="0">
              <a:buNone/>
              <a:defRPr sz="3094"/>
            </a:lvl2pPr>
            <a:lvl3pPr marL="1010503" indent="0">
              <a:buNone/>
              <a:defRPr sz="2652"/>
            </a:lvl3pPr>
            <a:lvl4pPr marL="1515755" indent="0">
              <a:buNone/>
              <a:defRPr sz="2210"/>
            </a:lvl4pPr>
            <a:lvl5pPr marL="2021007" indent="0">
              <a:buNone/>
              <a:defRPr sz="2210"/>
            </a:lvl5pPr>
            <a:lvl6pPr marL="2526259" indent="0">
              <a:buNone/>
              <a:defRPr sz="2210"/>
            </a:lvl6pPr>
            <a:lvl7pPr marL="3031510" indent="0">
              <a:buNone/>
              <a:defRPr sz="2210"/>
            </a:lvl7pPr>
            <a:lvl8pPr marL="3536762" indent="0">
              <a:buNone/>
              <a:defRPr sz="2210"/>
            </a:lvl8pPr>
            <a:lvl9pPr marL="4042014" indent="0">
              <a:buNone/>
              <a:defRPr sz="221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3789" y="2273617"/>
            <a:ext cx="4512856" cy="4212158"/>
          </a:xfrm>
        </p:spPr>
        <p:txBody>
          <a:bodyPr/>
          <a:lstStyle>
            <a:lvl1pPr marL="0" indent="0">
              <a:buNone/>
              <a:defRPr sz="1768"/>
            </a:lvl1pPr>
            <a:lvl2pPr marL="505252" indent="0">
              <a:buNone/>
              <a:defRPr sz="1547"/>
            </a:lvl2pPr>
            <a:lvl3pPr marL="1010503" indent="0">
              <a:buNone/>
              <a:defRPr sz="1326"/>
            </a:lvl3pPr>
            <a:lvl4pPr marL="1515755" indent="0">
              <a:buNone/>
              <a:defRPr sz="1105"/>
            </a:lvl4pPr>
            <a:lvl5pPr marL="2021007" indent="0">
              <a:buNone/>
              <a:defRPr sz="1105"/>
            </a:lvl5pPr>
            <a:lvl6pPr marL="2526259" indent="0">
              <a:buNone/>
              <a:defRPr sz="1105"/>
            </a:lvl6pPr>
            <a:lvl7pPr marL="3031510" indent="0">
              <a:buNone/>
              <a:defRPr sz="1105"/>
            </a:lvl7pPr>
            <a:lvl8pPr marL="3536762" indent="0">
              <a:buNone/>
              <a:defRPr sz="1105"/>
            </a:lvl8pPr>
            <a:lvl9pPr marL="4042014" indent="0">
              <a:buNone/>
              <a:defRPr sz="110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924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61966" y="403497"/>
            <a:ext cx="12068294" cy="1464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1966" y="2017485"/>
            <a:ext cx="12068294" cy="4808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61965" y="7024356"/>
            <a:ext cx="3148251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3838C-F5E1-7344-987D-A583C0F4AE4B}" type="datetimeFigureOut">
              <a:rPr lang="en-DE" smtClean="0"/>
              <a:t>01/11/20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34925" y="7024356"/>
            <a:ext cx="4722376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82009" y="7024356"/>
            <a:ext cx="3148251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7D9F1-AF1F-1742-BCD6-F28FB51794E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0605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10503" rtl="0" eaLnBrk="1" latinLnBrk="0" hangingPunct="1">
        <a:lnSpc>
          <a:spcPct val="90000"/>
        </a:lnSpc>
        <a:spcBef>
          <a:spcPct val="0"/>
        </a:spcBef>
        <a:buNone/>
        <a:defRPr sz="48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626" indent="-252626" algn="l" defTabSz="1010503" rtl="0" eaLnBrk="1" latinLnBrk="0" hangingPunct="1">
        <a:lnSpc>
          <a:spcPct val="90000"/>
        </a:lnSpc>
        <a:spcBef>
          <a:spcPts val="1105"/>
        </a:spcBef>
        <a:buFont typeface="Arial" panose="020B0604020202020204" pitchFamily="34" charset="0"/>
        <a:buChar char="•"/>
        <a:defRPr sz="3094" kern="1200">
          <a:solidFill>
            <a:schemeClr val="tx1"/>
          </a:solidFill>
          <a:latin typeface="+mn-lt"/>
          <a:ea typeface="+mn-ea"/>
          <a:cs typeface="+mn-cs"/>
        </a:defRPr>
      </a:lvl1pPr>
      <a:lvl2pPr marL="757878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2652" kern="1200">
          <a:solidFill>
            <a:schemeClr val="tx1"/>
          </a:solidFill>
          <a:latin typeface="+mn-lt"/>
          <a:ea typeface="+mn-ea"/>
          <a:cs typeface="+mn-cs"/>
        </a:defRPr>
      </a:lvl2pPr>
      <a:lvl3pPr marL="1263129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2210" kern="1200">
          <a:solidFill>
            <a:schemeClr val="tx1"/>
          </a:solidFill>
          <a:latin typeface="+mn-lt"/>
          <a:ea typeface="+mn-ea"/>
          <a:cs typeface="+mn-cs"/>
        </a:defRPr>
      </a:lvl3pPr>
      <a:lvl4pPr marL="1768381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4pPr>
      <a:lvl5pPr marL="2273633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5pPr>
      <a:lvl6pPr marL="2778884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6pPr>
      <a:lvl7pPr marL="3284136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7pPr>
      <a:lvl8pPr marL="3789388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8pPr>
      <a:lvl9pPr marL="4294640" indent="-252626" algn="l" defTabSz="1010503" rtl="0" eaLnBrk="1" latinLnBrk="0" hangingPunct="1">
        <a:lnSpc>
          <a:spcPct val="90000"/>
        </a:lnSpc>
        <a:spcBef>
          <a:spcPts val="553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1pPr>
      <a:lvl2pPr marL="505252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2pPr>
      <a:lvl3pPr marL="1010503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3pPr>
      <a:lvl4pPr marL="1515755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4pPr>
      <a:lvl5pPr marL="2021007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5pPr>
      <a:lvl6pPr marL="2526259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6pPr>
      <a:lvl7pPr marL="3031510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7pPr>
      <a:lvl8pPr marL="3536762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8pPr>
      <a:lvl9pPr marL="4042014" algn="l" defTabSz="1010503" rtl="0" eaLnBrk="1" latinLnBrk="0" hangingPunct="1">
        <a:defRPr sz="19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avi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4.avi"/><Relationship Id="rId7" Type="http://schemas.openxmlformats.org/officeDocument/2006/relationships/image" Target="../media/image4.png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4.avi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6.avi"/><Relationship Id="rId7" Type="http://schemas.openxmlformats.org/officeDocument/2006/relationships/image" Target="../media/image6.png"/><Relationship Id="rId2" Type="http://schemas.openxmlformats.org/officeDocument/2006/relationships/video" Target="../media/media5.avi"/><Relationship Id="rId1" Type="http://schemas.microsoft.com/office/2007/relationships/media" Target="../media/media5.avi"/><Relationship Id="rId6" Type="http://schemas.openxmlformats.org/officeDocument/2006/relationships/image" Target="../media/image5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6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EDC07C81">
            <a:hlinkClick r:id="" action="ppaction://media"/>
            <a:extLst>
              <a:ext uri="{FF2B5EF4-FFF2-40B4-BE49-F238E27FC236}">
                <a16:creationId xmlns:a16="http://schemas.microsoft.com/office/drawing/2014/main" id="{8F56C636-A19A-4C1A-95B6-50CF422F5A4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722275" y="1590784"/>
            <a:ext cx="6074549" cy="4555912"/>
          </a:xfrm>
          <a:prstGeom prst="rect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4" name="2B7BA470">
            <a:hlinkClick r:id="" action="ppaction://media"/>
            <a:extLst>
              <a:ext uri="{FF2B5EF4-FFF2-40B4-BE49-F238E27FC236}">
                <a16:creationId xmlns:a16="http://schemas.microsoft.com/office/drawing/2014/main" id="{BCA830A6-A887-4259-B56D-9CD85F23FA15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195401" y="1590784"/>
            <a:ext cx="6074549" cy="4555912"/>
          </a:xfrm>
          <a:prstGeom prst="rect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4FC82D1C-89E4-4D6E-B066-AFDD03BFA5B6}"/>
              </a:ext>
            </a:extLst>
          </p:cNvPr>
          <p:cNvSpPr txBox="1"/>
          <p:nvPr/>
        </p:nvSpPr>
        <p:spPr>
          <a:xfrm>
            <a:off x="1984917" y="907425"/>
            <a:ext cx="3670044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/>
              <a:t>3 chamber view at baseline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164C03B6-9459-456E-A401-27B86B4D12D2}"/>
              </a:ext>
            </a:extLst>
          </p:cNvPr>
          <p:cNvSpPr txBox="1"/>
          <p:nvPr/>
        </p:nvSpPr>
        <p:spPr>
          <a:xfrm>
            <a:off x="8361425" y="907425"/>
            <a:ext cx="3742499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 dirty="0"/>
              <a:t>3 chamber view at follow-up</a:t>
            </a:r>
          </a:p>
        </p:txBody>
      </p:sp>
    </p:spTree>
    <p:extLst>
      <p:ext uri="{BB962C8B-B14F-4D97-AF65-F5344CB8AC3E}">
        <p14:creationId xmlns:p14="http://schemas.microsoft.com/office/powerpoint/2010/main" val="33097709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3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43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424C3A59">
            <a:hlinkClick r:id="" action="ppaction://media"/>
            <a:extLst>
              <a:ext uri="{FF2B5EF4-FFF2-40B4-BE49-F238E27FC236}">
                <a16:creationId xmlns:a16="http://schemas.microsoft.com/office/drawing/2014/main" id="{F80EC23C-B648-4D32-8205-1E009DED518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7234587" y="1590858"/>
            <a:ext cx="5862677" cy="4397008"/>
          </a:xfrm>
          <a:prstGeom prst="rect">
            <a:avLst/>
          </a:prstGeom>
        </p:spPr>
      </p:pic>
      <p:pic>
        <p:nvPicPr>
          <p:cNvPr id="3" name="129D272B">
            <a:hlinkClick r:id="" action="ppaction://media"/>
            <a:extLst>
              <a:ext uri="{FF2B5EF4-FFF2-40B4-BE49-F238E27FC236}">
                <a16:creationId xmlns:a16="http://schemas.microsoft.com/office/drawing/2014/main" id="{A8DB7AAB-9E2C-4BC2-AC80-9B74DC7EFBB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894962" y="1590858"/>
            <a:ext cx="5862677" cy="4397008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B053A6EC-5AF3-4947-AFDB-A3F071719E8D}"/>
              </a:ext>
            </a:extLst>
          </p:cNvPr>
          <p:cNvSpPr txBox="1"/>
          <p:nvPr/>
        </p:nvSpPr>
        <p:spPr>
          <a:xfrm>
            <a:off x="1984917" y="915862"/>
            <a:ext cx="3670044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 dirty="0"/>
              <a:t>2 chamber view at baseline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D0FB7109-005A-49F7-AD42-48B9BF237A64}"/>
              </a:ext>
            </a:extLst>
          </p:cNvPr>
          <p:cNvSpPr txBox="1"/>
          <p:nvPr/>
        </p:nvSpPr>
        <p:spPr>
          <a:xfrm>
            <a:off x="8361425" y="915862"/>
            <a:ext cx="3742499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 dirty="0"/>
              <a:t>2 chamber view at follow-up</a:t>
            </a:r>
          </a:p>
        </p:txBody>
      </p:sp>
    </p:spTree>
    <p:extLst>
      <p:ext uri="{BB962C8B-B14F-4D97-AF65-F5344CB8AC3E}">
        <p14:creationId xmlns:p14="http://schemas.microsoft.com/office/powerpoint/2010/main" val="24459304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3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435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DE24A02">
            <a:hlinkClick r:id="" action="ppaction://media"/>
            <a:extLst>
              <a:ext uri="{FF2B5EF4-FFF2-40B4-BE49-F238E27FC236}">
                <a16:creationId xmlns:a16="http://schemas.microsoft.com/office/drawing/2014/main" id="{C1CBB8ED-7271-4E81-AEE0-854ACF45D56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40697" y="1664030"/>
            <a:ext cx="6141456" cy="4606092"/>
          </a:xfrm>
          <a:prstGeom prst="rect">
            <a:avLst/>
          </a:prstGeom>
        </p:spPr>
      </p:pic>
      <p:pic>
        <p:nvPicPr>
          <p:cNvPr id="3" name="6820073C">
            <a:hlinkClick r:id="" action="ppaction://media"/>
            <a:extLst>
              <a:ext uri="{FF2B5EF4-FFF2-40B4-BE49-F238E27FC236}">
                <a16:creationId xmlns:a16="http://schemas.microsoft.com/office/drawing/2014/main" id="{E0C123D1-2914-4859-8010-7A067891040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12813" t="12605" r="13960" b="12604"/>
          <a:stretch/>
        </p:blipFill>
        <p:spPr>
          <a:xfrm>
            <a:off x="6996112" y="1664030"/>
            <a:ext cx="6141456" cy="4606092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E664A1D-81BE-4C81-8F67-3A7113566DD7}"/>
              </a:ext>
            </a:extLst>
          </p:cNvPr>
          <p:cNvSpPr txBox="1"/>
          <p:nvPr/>
        </p:nvSpPr>
        <p:spPr>
          <a:xfrm>
            <a:off x="1819083" y="1016833"/>
            <a:ext cx="3670044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 dirty="0"/>
              <a:t>4 chamber view at baseline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F36673F1-A398-4176-8221-A82594C1BEAA}"/>
              </a:ext>
            </a:extLst>
          </p:cNvPr>
          <p:cNvSpPr txBox="1"/>
          <p:nvPr/>
        </p:nvSpPr>
        <p:spPr>
          <a:xfrm>
            <a:off x="8195591" y="1016833"/>
            <a:ext cx="3742499" cy="46166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AU" sz="2400" dirty="0"/>
              <a:t>4 chamber view at follow-up</a:t>
            </a:r>
          </a:p>
        </p:txBody>
      </p:sp>
    </p:spTree>
    <p:extLst>
      <p:ext uri="{BB962C8B-B14F-4D97-AF65-F5344CB8AC3E}">
        <p14:creationId xmlns:p14="http://schemas.microsoft.com/office/powerpoint/2010/main" val="29297478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3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435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</Words>
  <Application>Microsoft Office PowerPoint</Application>
  <PresentationFormat>Benutzerdefiniert</PresentationFormat>
  <Paragraphs>6</Paragraphs>
  <Slides>3</Slides>
  <Notes>0</Notes>
  <HiddenSlides>0</HiddenSlides>
  <MMClips>6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rin Giusca</dc:creator>
  <cp:lastModifiedBy>Grigorios Korosoglou</cp:lastModifiedBy>
  <cp:revision>8</cp:revision>
  <dcterms:created xsi:type="dcterms:W3CDTF">2021-12-26T06:55:37Z</dcterms:created>
  <dcterms:modified xsi:type="dcterms:W3CDTF">2022-01-11T19:20:13Z</dcterms:modified>
</cp:coreProperties>
</file>